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3" r:id="rId2"/>
    <p:sldId id="261" r:id="rId3"/>
    <p:sldId id="262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10" d="100"/>
          <a:sy n="110" d="100"/>
        </p:scale>
        <p:origin x="-1788" y="75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UY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8F1E98-A9B5-4355-93D2-B6DED771574F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UY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27DA4D-9BB9-42FA-AC5C-872E3FAA7B39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40599281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85BC-565C-4C0C-B444-D7562C04ABD0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0FF5B-FCD0-45CF-BE0D-7DFF8B30D6B1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903740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85BC-565C-4C0C-B444-D7562C04ABD0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0FF5B-FCD0-45CF-BE0D-7DFF8B30D6B1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705445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85BC-565C-4C0C-B444-D7562C04ABD0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0FF5B-FCD0-45CF-BE0D-7DFF8B30D6B1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371582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85BC-565C-4C0C-B444-D7562C04ABD0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0FF5B-FCD0-45CF-BE0D-7DFF8B30D6B1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321261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85BC-565C-4C0C-B444-D7562C04ABD0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0FF5B-FCD0-45CF-BE0D-7DFF8B30D6B1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914129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85BC-565C-4C0C-B444-D7562C04ABD0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0FF5B-FCD0-45CF-BE0D-7DFF8B30D6B1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92186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85BC-565C-4C0C-B444-D7562C04ABD0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0FF5B-FCD0-45CF-BE0D-7DFF8B30D6B1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269094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85BC-565C-4C0C-B444-D7562C04ABD0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0FF5B-FCD0-45CF-BE0D-7DFF8B30D6B1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653220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85BC-565C-4C0C-B444-D7562C04ABD0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0FF5B-FCD0-45CF-BE0D-7DFF8B30D6B1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1613179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85BC-565C-4C0C-B444-D7562C04ABD0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0FF5B-FCD0-45CF-BE0D-7DFF8B30D6B1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1459336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UY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B185BC-565C-4C0C-B444-D7562C04ABD0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UY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0FF5B-FCD0-45CF-BE0D-7DFF8B30D6B1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2681737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UY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UY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B185BC-565C-4C0C-B444-D7562C04ABD0}" type="datetimeFigureOut">
              <a:rPr lang="es-UY" smtClean="0"/>
              <a:t>08/03/2016</a:t>
            </a:fld>
            <a:endParaRPr lang="es-UY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UY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70FF5B-FCD0-45CF-BE0D-7DFF8B30D6B1}" type="slidenum">
              <a:rPr lang="es-UY" smtClean="0"/>
              <a:t>‹Nº›</a:t>
            </a:fld>
            <a:endParaRPr lang="es-UY"/>
          </a:p>
        </p:txBody>
      </p:sp>
    </p:spTree>
    <p:extLst>
      <p:ext uri="{BB962C8B-B14F-4D97-AF65-F5344CB8AC3E}">
        <p14:creationId xmlns:p14="http://schemas.microsoft.com/office/powerpoint/2010/main" val="3606777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312613" y="395536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UY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es-UY" b="1" dirty="0" smtClean="0">
                <a:latin typeface="Arial" pitchFamily="34" charset="0"/>
                <a:cs typeface="Arial" pitchFamily="34" charset="0"/>
              </a:rPr>
              <a:t> Figure 1</a:t>
            </a:r>
            <a:endParaRPr lang="es-UY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3 Grupo"/>
          <p:cNvGrpSpPr/>
          <p:nvPr/>
        </p:nvGrpSpPr>
        <p:grpSpPr>
          <a:xfrm>
            <a:off x="1850955" y="2144890"/>
            <a:ext cx="3641320" cy="4074956"/>
            <a:chOff x="2946904" y="476744"/>
            <a:chExt cx="3641320" cy="4074956"/>
          </a:xfrm>
        </p:grpSpPr>
        <p:sp>
          <p:nvSpPr>
            <p:cNvPr id="5" name="4 Elipse"/>
            <p:cNvSpPr/>
            <p:nvPr/>
          </p:nvSpPr>
          <p:spPr>
            <a:xfrm>
              <a:off x="3059856" y="476744"/>
              <a:ext cx="1440000" cy="5760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b="1" smtClean="0">
                  <a:latin typeface="Arial" pitchFamily="34" charset="0"/>
                  <a:cs typeface="Arial" pitchFamily="34" charset="0"/>
                </a:rPr>
                <a:t>PI3K </a:t>
              </a:r>
            </a:p>
            <a:p>
              <a:pPr algn="ctr"/>
              <a:r>
                <a:rPr lang="en-GB" b="1" smtClean="0">
                  <a:latin typeface="Arial" pitchFamily="34" charset="0"/>
                  <a:cs typeface="Arial" pitchFamily="34" charset="0"/>
                </a:rPr>
                <a:t>class I</a:t>
              </a:r>
              <a:endParaRPr lang="en-GB" b="1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5 Elipse"/>
            <p:cNvSpPr/>
            <p:nvPr/>
          </p:nvSpPr>
          <p:spPr>
            <a:xfrm>
              <a:off x="3059856" y="1756072"/>
              <a:ext cx="1440000" cy="5760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s-UY" b="1" dirty="0" smtClean="0">
                  <a:latin typeface="Arial" pitchFamily="34" charset="0"/>
                  <a:cs typeface="Arial" pitchFamily="34" charset="0"/>
                </a:rPr>
                <a:t>Akt</a:t>
              </a:r>
              <a:endParaRPr lang="es-UY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6 Elipse"/>
            <p:cNvSpPr/>
            <p:nvPr/>
          </p:nvSpPr>
          <p:spPr>
            <a:xfrm>
              <a:off x="3059856" y="3048512"/>
              <a:ext cx="1440000" cy="5760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s-UY" b="1" dirty="0" smtClean="0">
                  <a:latin typeface="Arial" pitchFamily="34" charset="0"/>
                  <a:cs typeface="Arial" pitchFamily="34" charset="0"/>
                </a:rPr>
                <a:t>GSK3</a:t>
              </a:r>
              <a:endParaRPr lang="es-UY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" name="7 Conector recto de flecha"/>
            <p:cNvCxnSpPr/>
            <p:nvPr/>
          </p:nvCxnSpPr>
          <p:spPr>
            <a:xfrm rot="5400000">
              <a:off x="3545616" y="1366628"/>
              <a:ext cx="432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" name="8 Grupo"/>
            <p:cNvGrpSpPr/>
            <p:nvPr/>
          </p:nvGrpSpPr>
          <p:grpSpPr>
            <a:xfrm>
              <a:off x="3671616" y="2467856"/>
              <a:ext cx="180000" cy="432000"/>
              <a:chOff x="4704512" y="1286654"/>
              <a:chExt cx="180000" cy="612000"/>
            </a:xfrm>
          </p:grpSpPr>
          <p:cxnSp>
            <p:nvCxnSpPr>
              <p:cNvPr id="30" name="29 Conector recto"/>
              <p:cNvCxnSpPr/>
              <p:nvPr/>
            </p:nvCxnSpPr>
            <p:spPr>
              <a:xfrm rot="5400000">
                <a:off x="4488512" y="1591860"/>
                <a:ext cx="612000" cy="1588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30 Conector recto"/>
              <p:cNvCxnSpPr/>
              <p:nvPr/>
            </p:nvCxnSpPr>
            <p:spPr>
              <a:xfrm rot="10800000" flipV="1">
                <a:off x="4704512" y="1882447"/>
                <a:ext cx="180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" name="9 Conector recto de flecha"/>
            <p:cNvCxnSpPr/>
            <p:nvPr/>
          </p:nvCxnSpPr>
          <p:spPr>
            <a:xfrm rot="16200000" flipH="1">
              <a:off x="3863643" y="3840665"/>
              <a:ext cx="428628" cy="214314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" name="10 Grupo"/>
            <p:cNvGrpSpPr/>
            <p:nvPr/>
          </p:nvGrpSpPr>
          <p:grpSpPr>
            <a:xfrm rot="1553591">
              <a:off x="3393423" y="3687694"/>
              <a:ext cx="180000" cy="432000"/>
              <a:chOff x="4704512" y="1286654"/>
              <a:chExt cx="180000" cy="612000"/>
            </a:xfrm>
          </p:grpSpPr>
          <p:cxnSp>
            <p:nvCxnSpPr>
              <p:cNvPr id="28" name="27 Conector recto"/>
              <p:cNvCxnSpPr/>
              <p:nvPr/>
            </p:nvCxnSpPr>
            <p:spPr>
              <a:xfrm rot="5400000">
                <a:off x="4488512" y="1591860"/>
                <a:ext cx="612000" cy="1588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28 Conector recto"/>
              <p:cNvCxnSpPr/>
              <p:nvPr/>
            </p:nvCxnSpPr>
            <p:spPr>
              <a:xfrm rot="10800000" flipV="1">
                <a:off x="4704512" y="1882447"/>
                <a:ext cx="180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" name="11 CuadroTexto"/>
            <p:cNvSpPr txBox="1"/>
            <p:nvPr/>
          </p:nvSpPr>
          <p:spPr>
            <a:xfrm>
              <a:off x="3947036" y="4182368"/>
              <a:ext cx="7232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UY" b="1" dirty="0" smtClean="0">
                  <a:latin typeface="Arial" pitchFamily="34" charset="0"/>
                  <a:cs typeface="Arial" pitchFamily="34" charset="0"/>
                </a:rPr>
                <a:t>IL-12</a:t>
              </a:r>
              <a:endParaRPr lang="es-UY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12 CuadroTexto"/>
            <p:cNvSpPr txBox="1"/>
            <p:nvPr/>
          </p:nvSpPr>
          <p:spPr>
            <a:xfrm>
              <a:off x="2972414" y="4182368"/>
              <a:ext cx="7232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UY" b="1" dirty="0" smtClean="0">
                  <a:latin typeface="Arial" pitchFamily="34" charset="0"/>
                  <a:cs typeface="Arial" pitchFamily="34" charset="0"/>
                </a:rPr>
                <a:t>IL-10</a:t>
              </a:r>
              <a:endParaRPr lang="es-UY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13 CuadroTexto"/>
            <p:cNvSpPr txBox="1"/>
            <p:nvPr/>
          </p:nvSpPr>
          <p:spPr>
            <a:xfrm>
              <a:off x="3275880" y="1151478"/>
              <a:ext cx="4732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UY" b="1" dirty="0" smtClean="0">
                  <a:latin typeface="Arial" pitchFamily="34" charset="0"/>
                  <a:cs typeface="Arial" pitchFamily="34" charset="0"/>
                </a:rPr>
                <a:t>(+)</a:t>
              </a:r>
              <a:endParaRPr lang="es-UY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14 CuadroTexto"/>
            <p:cNvSpPr txBox="1"/>
            <p:nvPr/>
          </p:nvSpPr>
          <p:spPr>
            <a:xfrm>
              <a:off x="3293468" y="2481504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UY" b="1" dirty="0" smtClean="0">
                  <a:latin typeface="Arial" pitchFamily="34" charset="0"/>
                  <a:cs typeface="Arial" pitchFamily="34" charset="0"/>
                </a:rPr>
                <a:t>(-)</a:t>
              </a:r>
              <a:endParaRPr lang="es-UY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15 CuadroTexto"/>
            <p:cNvSpPr txBox="1"/>
            <p:nvPr/>
          </p:nvSpPr>
          <p:spPr>
            <a:xfrm>
              <a:off x="4161350" y="3638160"/>
              <a:ext cx="4732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UY" b="1" dirty="0" smtClean="0">
                  <a:latin typeface="Arial" pitchFamily="34" charset="0"/>
                  <a:cs typeface="Arial" pitchFamily="34" charset="0"/>
                </a:rPr>
                <a:t>(+)</a:t>
              </a:r>
              <a:endParaRPr lang="es-UY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16 CuadroTexto"/>
            <p:cNvSpPr txBox="1"/>
            <p:nvPr/>
          </p:nvSpPr>
          <p:spPr>
            <a:xfrm>
              <a:off x="2946904" y="3638160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UY" b="1" dirty="0" smtClean="0">
                  <a:latin typeface="Arial" pitchFamily="34" charset="0"/>
                  <a:cs typeface="Arial" pitchFamily="34" charset="0"/>
                </a:rPr>
                <a:t>(-)</a:t>
              </a:r>
              <a:endParaRPr lang="es-UY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17 Elipse"/>
            <p:cNvSpPr/>
            <p:nvPr/>
          </p:nvSpPr>
          <p:spPr>
            <a:xfrm>
              <a:off x="5148224" y="1756072"/>
              <a:ext cx="1440000" cy="5760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sz="1500" b="1" dirty="0" smtClean="0">
                  <a:latin typeface="Arial" pitchFamily="34" charset="0"/>
                  <a:cs typeface="Arial" pitchFamily="34" charset="0"/>
                </a:rPr>
                <a:t>mTORC</a:t>
              </a:r>
              <a:r>
                <a:rPr lang="en-GB" sz="1400" b="1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GB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18 Elipse"/>
            <p:cNvSpPr/>
            <p:nvPr/>
          </p:nvSpPr>
          <p:spPr>
            <a:xfrm>
              <a:off x="5148224" y="3048512"/>
              <a:ext cx="1440000" cy="576000"/>
            </a:xfrm>
            <a:prstGeom prst="ellipse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GB" b="1" dirty="0" smtClean="0">
                  <a:latin typeface="Arial" pitchFamily="34" charset="0"/>
                  <a:cs typeface="Arial" pitchFamily="34" charset="0"/>
                </a:rPr>
                <a:t>S6K</a:t>
              </a:r>
              <a:endParaRPr lang="en-GB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0" name="19 Conector recto de flecha"/>
            <p:cNvCxnSpPr/>
            <p:nvPr/>
          </p:nvCxnSpPr>
          <p:spPr>
            <a:xfrm flipV="1">
              <a:off x="4602716" y="2044072"/>
              <a:ext cx="432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20 Grupo"/>
            <p:cNvGrpSpPr/>
            <p:nvPr/>
          </p:nvGrpSpPr>
          <p:grpSpPr>
            <a:xfrm rot="5400000">
              <a:off x="4726113" y="3120512"/>
              <a:ext cx="180000" cy="432000"/>
              <a:chOff x="4704512" y="1286654"/>
              <a:chExt cx="180000" cy="612000"/>
            </a:xfrm>
          </p:grpSpPr>
          <p:cxnSp>
            <p:nvCxnSpPr>
              <p:cNvPr id="26" name="25 Conector recto"/>
              <p:cNvCxnSpPr/>
              <p:nvPr/>
            </p:nvCxnSpPr>
            <p:spPr>
              <a:xfrm rot="5400000">
                <a:off x="4488512" y="1591860"/>
                <a:ext cx="612000" cy="1588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26 Conector recto"/>
              <p:cNvCxnSpPr/>
              <p:nvPr/>
            </p:nvCxnSpPr>
            <p:spPr>
              <a:xfrm rot="10800000" flipV="1">
                <a:off x="4704512" y="1882447"/>
                <a:ext cx="1800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2" name="21 Conector recto de flecha"/>
            <p:cNvCxnSpPr/>
            <p:nvPr/>
          </p:nvCxnSpPr>
          <p:spPr>
            <a:xfrm rot="5400000">
              <a:off x="5652224" y="2699761"/>
              <a:ext cx="432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22 CuadroTexto"/>
            <p:cNvSpPr txBox="1"/>
            <p:nvPr/>
          </p:nvSpPr>
          <p:spPr>
            <a:xfrm>
              <a:off x="4568011" y="1598946"/>
              <a:ext cx="4732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UY" b="1" dirty="0" smtClean="0">
                  <a:latin typeface="Arial" pitchFamily="34" charset="0"/>
                  <a:cs typeface="Arial" pitchFamily="34" charset="0"/>
                </a:rPr>
                <a:t>(+)</a:t>
              </a:r>
              <a:endParaRPr lang="es-UY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23 CuadroTexto"/>
            <p:cNvSpPr txBox="1"/>
            <p:nvPr/>
          </p:nvSpPr>
          <p:spPr>
            <a:xfrm>
              <a:off x="5355014" y="2525758"/>
              <a:ext cx="4732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UY" b="1" dirty="0" smtClean="0">
                  <a:latin typeface="Arial" pitchFamily="34" charset="0"/>
                  <a:cs typeface="Arial" pitchFamily="34" charset="0"/>
                </a:rPr>
                <a:t>(+)</a:t>
              </a:r>
              <a:endParaRPr lang="es-UY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24 CuadroTexto"/>
            <p:cNvSpPr txBox="1"/>
            <p:nvPr/>
          </p:nvSpPr>
          <p:spPr>
            <a:xfrm>
              <a:off x="4590453" y="2915761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UY" b="1" dirty="0" smtClean="0">
                  <a:latin typeface="Arial" pitchFamily="34" charset="0"/>
                  <a:cs typeface="Arial" pitchFamily="34" charset="0"/>
                </a:rPr>
                <a:t>(-)</a:t>
              </a:r>
              <a:endParaRPr lang="es-UY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77522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312613" y="395536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UY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es-UY" b="1" dirty="0" smtClean="0">
                <a:latin typeface="Arial" pitchFamily="34" charset="0"/>
                <a:cs typeface="Arial" pitchFamily="34" charset="0"/>
              </a:rPr>
              <a:t> Figure 2</a:t>
            </a:r>
            <a:endParaRPr lang="es-UY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3 Grupo"/>
          <p:cNvGrpSpPr/>
          <p:nvPr/>
        </p:nvGrpSpPr>
        <p:grpSpPr>
          <a:xfrm>
            <a:off x="1556792" y="1475656"/>
            <a:ext cx="3327623" cy="2789508"/>
            <a:chOff x="1556792" y="1475656"/>
            <a:chExt cx="3327623" cy="2789508"/>
          </a:xfrm>
        </p:grpSpPr>
        <p:pic>
          <p:nvPicPr>
            <p:cNvPr id="3074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56792" y="1475656"/>
              <a:ext cx="3327623" cy="278950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2 CuadroTexto"/>
            <p:cNvSpPr txBox="1"/>
            <p:nvPr/>
          </p:nvSpPr>
          <p:spPr>
            <a:xfrm rot="16200000">
              <a:off x="3691896" y="2413509"/>
              <a:ext cx="196239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UY" sz="1400" dirty="0" smtClean="0">
                  <a:latin typeface="Arial" pitchFamily="34" charset="0"/>
                  <a:cs typeface="Arial" pitchFamily="34" charset="0"/>
                </a:rPr>
                <a:t>GDC-0941 + SAR405 </a:t>
              </a:r>
              <a:endParaRPr lang="es-UY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" name="4 CuadroTexto"/>
          <p:cNvSpPr txBox="1"/>
          <p:nvPr/>
        </p:nvSpPr>
        <p:spPr>
          <a:xfrm>
            <a:off x="1769408" y="3445133"/>
            <a:ext cx="663964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UY" sz="1600" dirty="0" smtClean="0">
                <a:latin typeface="Arial" pitchFamily="34" charset="0"/>
                <a:cs typeface="Arial" pitchFamily="34" charset="0"/>
              </a:rPr>
              <a:t>p-</a:t>
            </a:r>
            <a:r>
              <a:rPr lang="es-UY" sz="1600" dirty="0" err="1" smtClean="0">
                <a:latin typeface="Arial" pitchFamily="34" charset="0"/>
                <a:cs typeface="Arial" pitchFamily="34" charset="0"/>
              </a:rPr>
              <a:t>Akt</a:t>
            </a:r>
            <a:endParaRPr lang="es-UY" sz="1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01750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CuadroTexto"/>
          <p:cNvSpPr txBox="1"/>
          <p:nvPr/>
        </p:nvSpPr>
        <p:spPr>
          <a:xfrm>
            <a:off x="169067" y="467544"/>
            <a:ext cx="1787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UY" b="1" dirty="0" err="1" smtClean="0">
                <a:latin typeface="Arial" pitchFamily="34" charset="0"/>
                <a:cs typeface="Arial" pitchFamily="34" charset="0"/>
              </a:rPr>
              <a:t>Suppl</a:t>
            </a:r>
            <a:r>
              <a:rPr lang="es-UY" b="1" dirty="0" smtClean="0">
                <a:latin typeface="Arial" pitchFamily="34" charset="0"/>
                <a:cs typeface="Arial" pitchFamily="34" charset="0"/>
              </a:rPr>
              <a:t> Figure 3</a:t>
            </a:r>
            <a:endParaRPr lang="es-UY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" name="Picture 8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612" t="14820" r="21782" b="54943"/>
          <a:stretch/>
        </p:blipFill>
        <p:spPr bwMode="auto">
          <a:xfrm>
            <a:off x="4385200" y="3608663"/>
            <a:ext cx="1187592" cy="8805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685"/>
          <a:stretch/>
        </p:blipFill>
        <p:spPr bwMode="auto">
          <a:xfrm>
            <a:off x="1849000" y="4040867"/>
            <a:ext cx="2407824" cy="18722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351"/>
          <a:stretch/>
        </p:blipFill>
        <p:spPr bwMode="auto">
          <a:xfrm>
            <a:off x="1844824" y="1835696"/>
            <a:ext cx="2412000" cy="20016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678787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29</Words>
  <Application>Microsoft Office PowerPoint</Application>
  <PresentationFormat>Presentación en pantalla (4:3)</PresentationFormat>
  <Paragraphs>20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Presentación de PowerPoint</vt:lpstr>
      <vt:lpstr>Presentación de PowerPoint</vt:lpstr>
      <vt:lpstr>Presentación de PowerPoint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as final</dc:title>
  <dc:creator>usuario</dc:creator>
  <cp:lastModifiedBy>Usuario1</cp:lastModifiedBy>
  <cp:revision>26</cp:revision>
  <dcterms:created xsi:type="dcterms:W3CDTF">2015-10-02T17:28:48Z</dcterms:created>
  <dcterms:modified xsi:type="dcterms:W3CDTF">2016-03-08T20:17:27Z</dcterms:modified>
</cp:coreProperties>
</file>